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18"/>
  </p:normalViewPr>
  <p:slideViewPr>
    <p:cSldViewPr snapToGrid="0" snapToObjects="1">
      <p:cViewPr varScale="1">
        <p:scale>
          <a:sx n="116" d="100"/>
          <a:sy n="116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B7664A-A4CF-3C4F-8CC8-2A7556898F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C8DBE3C-BFAA-A24E-84A0-3E7D19DAEB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B21A2F-9213-1F48-A34A-523B41B05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D42724-D56D-AD4A-987C-230C3AD55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CD622BB-B850-3C41-956E-835F24EB7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79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77F668-F2AC-5D4F-9D63-D5FBFCC643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DBC144B-07AA-D34F-B14A-9B21C2C731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1B3024-E61D-0E44-8447-4B79260AC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687EC19-40F0-164F-AFCC-FDCD4E49D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6506F30-0FB5-0D4A-9000-3097114FA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5663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6E91BC0-E878-7541-82A5-42C9A374E7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7841816-0FD9-3E4D-85E6-F0A143457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BE64FE-5C0E-3543-8FF0-1A870BBC4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D8EF3E9-BDBC-C64E-92FA-973882206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59FC85-4B8E-F347-B6CE-677E99815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1388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90474-5850-3A46-8D89-1CD166868C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2DB01BD-FDD2-704C-A93F-8CC5F73A7D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25DB2CA-4250-D146-AB5F-7E09FDE69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D2C792A-C3E8-AB46-BA54-B95B319BB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C9A77C7-18A3-AE49-9D6F-4E6AD1DFB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3818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7CD4F2-45F1-2E4E-956E-D68A4CB1DA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D33FB37-446C-554D-8CEA-1E51D1A3F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8EC2D18-B15A-FC48-A200-626D3678A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88C24DE-ED94-0E42-A7C0-49C4DA306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AA45E4E-FB82-F645-BA87-3837B2B27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347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71DB93-49BE-2B49-9C40-9F50ABE8B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E82D4A-45F7-3142-B61F-EDBAD62312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68639C8-2A15-5546-A62F-85981A4C7D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0F7F995-83C3-4647-8EB4-1BF3FA0A1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E94B82B-0B5C-054C-B84F-78A8CF50B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2382031-A7D7-4C4E-9F15-16252FA6B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153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042D9E-FDA3-4540-9AB1-69D3F97C4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67A68F4-969E-E84B-9560-CE2C6518E9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09F3C08-9D2B-034B-B12F-39784F8D91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F65174B-A35A-DC45-8EEE-7DD4C8F397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456A213-DDA9-304D-9B90-D7E30747AE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9E57A7C-2890-6041-958D-52D169BC1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A10F36D-DF69-3143-A9C0-0DB709832F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65769F1-6141-9E4F-B53B-8DC8EF2D4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2855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423130-873A-BD42-B2C1-5BC0BD3C13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E7138AE-D6FD-3C40-9C2D-B7269E847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BCBE00D-1C6B-114B-A4D7-2825C005D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4FCD994-CA8A-9243-ABEC-53E61F155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677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3590B3C-4C97-0542-B54A-F101D1582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952475A-880A-7141-BBAE-9E60D0914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E2A6A22-244F-E44B-A756-B2BE55E8D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1509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96B1746-0BE3-8949-916B-AC7E57361F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4EC6DC2-218D-D549-8F99-BE4F04A526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E8EB43B-CE6E-0343-97AE-172354E054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1F913B7-5599-774B-81BD-47E83FCF6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B190C27-FBDF-C745-AEE6-E640BE680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7289E06-3386-2244-8A0A-20E4F658B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475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001752-62BF-D14F-B0B9-86F89DDC4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e l’image 2">
            <a:extLst>
              <a:ext uri="{FF2B5EF4-FFF2-40B4-BE49-F238E27FC236}">
                <a16:creationId xmlns:a16="http://schemas.microsoft.com/office/drawing/2014/main" id="{8F0331AB-6748-0844-A857-AF5F5A68E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D0AF6DF-DDED-6547-963B-383553D57F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24640FA-BFC6-5D40-8342-AB45D4731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B9E1C78-106E-AE42-802C-0C302F0C7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246D52E-B6D4-8140-9731-29054F817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4535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A4FED07-6C4E-F846-B101-66B8C53C2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87EF31-EAF1-9940-B51E-C949782B44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04F3F5D-1C02-3643-8FAE-FFA5873178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18A3E-BA80-8E40-A73A-0F2E601867ED}" type="datetimeFigureOut">
              <a:rPr lang="fr-FR" smtClean="0"/>
              <a:t>08/06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FCB09AC-F208-E74A-8950-E6AC18A315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0F5EB41-BF82-2941-8B22-FBE0F2529F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80EA04-F1CF-0841-88D6-5468D793CCA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0730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D70902F-0567-9C43-A3DE-34783CD82E70}"/>
              </a:ext>
            </a:extLst>
          </p:cNvPr>
          <p:cNvSpPr txBox="1"/>
          <p:nvPr/>
        </p:nvSpPr>
        <p:spPr>
          <a:xfrm>
            <a:off x="2474135" y="308584"/>
            <a:ext cx="29488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Helvetica" pitchFamily="2" charset="0"/>
              </a:rPr>
              <a:t>Harvest of TNBC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1FF2EDD-BBED-F243-86FA-47BA4710B5E6}"/>
              </a:ext>
            </a:extLst>
          </p:cNvPr>
          <p:cNvSpPr txBox="1"/>
          <p:nvPr/>
        </p:nvSpPr>
        <p:spPr>
          <a:xfrm>
            <a:off x="2878285" y="2169437"/>
            <a:ext cx="214059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Dissociated tumor cel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5A53D2-DC08-1C42-A7AA-695C0DF59396}"/>
              </a:ext>
            </a:extLst>
          </p:cNvPr>
          <p:cNvSpPr txBox="1"/>
          <p:nvPr/>
        </p:nvSpPr>
        <p:spPr>
          <a:xfrm>
            <a:off x="4828415" y="2663238"/>
            <a:ext cx="2509087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low freezing (-1ºC/min)</a:t>
            </a:r>
          </a:p>
          <a:p>
            <a:pPr algn="ctr"/>
            <a:r>
              <a:rPr lang="en-US" sz="1400" dirty="0">
                <a:latin typeface="Helvetica" pitchFamily="2" charset="0"/>
              </a:rPr>
              <a:t>-80°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E7CB0D-C027-5E4B-8B98-03BF34F80082}"/>
              </a:ext>
            </a:extLst>
          </p:cNvPr>
          <p:cNvSpPr txBox="1"/>
          <p:nvPr/>
        </p:nvSpPr>
        <p:spPr>
          <a:xfrm>
            <a:off x="7955271" y="2663238"/>
            <a:ext cx="144000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torage</a:t>
            </a:r>
          </a:p>
          <a:p>
            <a:pPr algn="ctr"/>
            <a:r>
              <a:rPr lang="en-US" sz="1400" dirty="0">
                <a:latin typeface="Helvetica" pitchFamily="2" charset="0"/>
              </a:rPr>
              <a:t>-150º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0688B67-1BA3-7B43-A7B0-CC716AFAD212}"/>
              </a:ext>
            </a:extLst>
          </p:cNvPr>
          <p:cNvSpPr txBox="1"/>
          <p:nvPr/>
        </p:nvSpPr>
        <p:spPr>
          <a:xfrm>
            <a:off x="1048215" y="2997276"/>
            <a:ext cx="173959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>
                <a:latin typeface="Helvetica" pitchFamily="2" charset="0"/>
              </a:rPr>
              <a:t>Multiparameter</a:t>
            </a:r>
            <a:r>
              <a:rPr lang="en-US" sz="1400" dirty="0">
                <a:latin typeface="Helvetica" pitchFamily="2" charset="0"/>
              </a:rPr>
              <a:t> cytometry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8C1DB25-F1B4-F84B-A851-3A8751B565F7}"/>
              </a:ext>
            </a:extLst>
          </p:cNvPr>
          <p:cNvSpPr txBox="1"/>
          <p:nvPr/>
        </p:nvSpPr>
        <p:spPr>
          <a:xfrm>
            <a:off x="3345540" y="3398650"/>
            <a:ext cx="1206085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Low adherence culture </a:t>
            </a:r>
          </a:p>
        </p:txBody>
      </p:sp>
      <p:cxnSp>
        <p:nvCxnSpPr>
          <p:cNvPr id="21" name="Elbow Connector 20">
            <a:extLst>
              <a:ext uri="{FF2B5EF4-FFF2-40B4-BE49-F238E27FC236}">
                <a16:creationId xmlns:a16="http://schemas.microsoft.com/office/drawing/2014/main" id="{20628B81-3E98-0A4E-91FA-FB08E3536583}"/>
              </a:ext>
            </a:extLst>
          </p:cNvPr>
          <p:cNvCxnSpPr>
            <a:cxnSpLocks/>
            <a:stCxn id="5" idx="1"/>
            <a:endCxn id="16" idx="0"/>
          </p:cNvCxnSpPr>
          <p:nvPr/>
        </p:nvCxnSpPr>
        <p:spPr>
          <a:xfrm rot="10800000" flipV="1">
            <a:off x="1918011" y="2323326"/>
            <a:ext cx="960275" cy="673950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Elbow Connector 36">
            <a:extLst>
              <a:ext uri="{FF2B5EF4-FFF2-40B4-BE49-F238E27FC236}">
                <a16:creationId xmlns:a16="http://schemas.microsoft.com/office/drawing/2014/main" id="{D593E3AB-A795-C14C-8F9F-C548DDA8AF1C}"/>
              </a:ext>
            </a:extLst>
          </p:cNvPr>
          <p:cNvCxnSpPr>
            <a:cxnSpLocks/>
            <a:stCxn id="15" idx="2"/>
            <a:endCxn id="82" idx="3"/>
          </p:cNvCxnSpPr>
          <p:nvPr/>
        </p:nvCxnSpPr>
        <p:spPr>
          <a:xfrm rot="5400000">
            <a:off x="7379845" y="2472556"/>
            <a:ext cx="581525" cy="2009329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EEC1CEF-6DB3-4B4F-ABDC-F4CCCA91116E}"/>
              </a:ext>
            </a:extLst>
          </p:cNvPr>
          <p:cNvSpPr txBox="1"/>
          <p:nvPr/>
        </p:nvSpPr>
        <p:spPr>
          <a:xfrm>
            <a:off x="1025913" y="5093339"/>
            <a:ext cx="1540636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>
                <a:latin typeface="Helvetica" pitchFamily="2" charset="0"/>
              </a:rPr>
              <a:t>Multiparameter</a:t>
            </a:r>
            <a:r>
              <a:rPr lang="en-US" sz="1400" dirty="0">
                <a:latin typeface="Helvetica" pitchFamily="2" charset="0"/>
              </a:rPr>
              <a:t> cytometry</a:t>
            </a:r>
          </a:p>
        </p:txBody>
      </p:sp>
      <p:cxnSp>
        <p:nvCxnSpPr>
          <p:cNvPr id="43" name="Elbow Connector 42">
            <a:extLst>
              <a:ext uri="{FF2B5EF4-FFF2-40B4-BE49-F238E27FC236}">
                <a16:creationId xmlns:a16="http://schemas.microsoft.com/office/drawing/2014/main" id="{23B542DB-7CA2-6043-B433-81E041F59A75}"/>
              </a:ext>
            </a:extLst>
          </p:cNvPr>
          <p:cNvCxnSpPr>
            <a:cxnSpLocks/>
            <a:stCxn id="106" idx="1"/>
            <a:endCxn id="42" idx="0"/>
          </p:cNvCxnSpPr>
          <p:nvPr/>
        </p:nvCxnSpPr>
        <p:spPr>
          <a:xfrm rot="10800000" flipV="1">
            <a:off x="1796232" y="4977141"/>
            <a:ext cx="1488941" cy="116197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2B4B5659-7CE8-8A49-8283-4A73FD30F6CE}"/>
              </a:ext>
            </a:extLst>
          </p:cNvPr>
          <p:cNvCxnSpPr>
            <a:cxnSpLocks/>
            <a:stCxn id="5" idx="2"/>
            <a:endCxn id="17" idx="0"/>
          </p:cNvCxnSpPr>
          <p:nvPr/>
        </p:nvCxnSpPr>
        <p:spPr>
          <a:xfrm>
            <a:off x="3948583" y="2477214"/>
            <a:ext cx="0" cy="92143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95A458A8-0A1A-EF4E-8118-869763D7F3D8}"/>
              </a:ext>
            </a:extLst>
          </p:cNvPr>
          <p:cNvCxnSpPr>
            <a:cxnSpLocks/>
            <a:stCxn id="10" idx="3"/>
            <a:endCxn id="15" idx="1"/>
          </p:cNvCxnSpPr>
          <p:nvPr/>
        </p:nvCxnSpPr>
        <p:spPr>
          <a:xfrm>
            <a:off x="7337502" y="2924848"/>
            <a:ext cx="61776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6FA465D9-A7AD-E340-8488-687FF6B2B698}"/>
              </a:ext>
            </a:extLst>
          </p:cNvPr>
          <p:cNvSpPr txBox="1"/>
          <p:nvPr/>
        </p:nvSpPr>
        <p:spPr>
          <a:xfrm>
            <a:off x="3345540" y="5512763"/>
            <a:ext cx="120608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RNA Extraction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8D99C06-52DA-9C40-8E5D-DE1AD88FA10A}"/>
              </a:ext>
            </a:extLst>
          </p:cNvPr>
          <p:cNvSpPr txBox="1"/>
          <p:nvPr/>
        </p:nvSpPr>
        <p:spPr>
          <a:xfrm>
            <a:off x="3345540" y="6195055"/>
            <a:ext cx="120608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Microarray</a:t>
            </a:r>
          </a:p>
          <a:p>
            <a:pPr algn="ctr"/>
            <a:r>
              <a:rPr lang="en-US" sz="1400" dirty="0">
                <a:latin typeface="Helvetica" pitchFamily="2" charset="0"/>
              </a:rPr>
              <a:t>Analysis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FE7AA51-7E98-6542-957C-124F3028B51E}"/>
              </a:ext>
            </a:extLst>
          </p:cNvPr>
          <p:cNvSpPr txBox="1"/>
          <p:nvPr/>
        </p:nvSpPr>
        <p:spPr>
          <a:xfrm>
            <a:off x="5674963" y="3614094"/>
            <a:ext cx="99097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Thawing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A608950-094E-CB49-A3DC-E7ABD2E45A5C}"/>
              </a:ext>
            </a:extLst>
          </p:cNvPr>
          <p:cNvSpPr txBox="1"/>
          <p:nvPr/>
        </p:nvSpPr>
        <p:spPr>
          <a:xfrm>
            <a:off x="7365000" y="3430902"/>
            <a:ext cx="99097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15 day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1390D40-D6C9-2944-BD2D-4666F404F099}"/>
              </a:ext>
            </a:extLst>
          </p:cNvPr>
          <p:cNvSpPr txBox="1"/>
          <p:nvPr/>
        </p:nvSpPr>
        <p:spPr>
          <a:xfrm>
            <a:off x="7149474" y="2621119"/>
            <a:ext cx="99097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24 h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FA5C1F8-D5DD-1C4A-AE6F-AF8D00EFC896}"/>
              </a:ext>
            </a:extLst>
          </p:cNvPr>
          <p:cNvSpPr txBox="1"/>
          <p:nvPr/>
        </p:nvSpPr>
        <p:spPr>
          <a:xfrm>
            <a:off x="3160837" y="1034067"/>
            <a:ext cx="1575490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Enzymatic &amp; mechanic dissociation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A826358E-3930-2F4F-ACE2-980737698194}"/>
              </a:ext>
            </a:extLst>
          </p:cNvPr>
          <p:cNvCxnSpPr>
            <a:cxnSpLocks/>
            <a:stCxn id="4" idx="2"/>
            <a:endCxn id="87" idx="0"/>
          </p:cNvCxnSpPr>
          <p:nvPr/>
        </p:nvCxnSpPr>
        <p:spPr>
          <a:xfrm>
            <a:off x="3948582" y="677916"/>
            <a:ext cx="0" cy="3561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B2D1AE91-D7B4-BB42-BCE1-1A84EA9D1790}"/>
              </a:ext>
            </a:extLst>
          </p:cNvPr>
          <p:cNvSpPr txBox="1"/>
          <p:nvPr/>
        </p:nvSpPr>
        <p:spPr>
          <a:xfrm>
            <a:off x="3285172" y="4607810"/>
            <a:ext cx="1326821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Helvetica" pitchFamily="2" charset="0"/>
              </a:rPr>
              <a:t>Spheroid (CSC enrichment)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289BE4B2-F05B-C14A-AC7A-54868BC03BD9}"/>
              </a:ext>
            </a:extLst>
          </p:cNvPr>
          <p:cNvCxnSpPr>
            <a:cxnSpLocks/>
            <a:stCxn id="87" idx="2"/>
            <a:endCxn id="5" idx="0"/>
          </p:cNvCxnSpPr>
          <p:nvPr/>
        </p:nvCxnSpPr>
        <p:spPr>
          <a:xfrm>
            <a:off x="3948582" y="1772731"/>
            <a:ext cx="1" cy="39670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D8319478-097B-5F49-BA07-83608D36DF73}"/>
              </a:ext>
            </a:extLst>
          </p:cNvPr>
          <p:cNvCxnSpPr>
            <a:cxnSpLocks/>
            <a:stCxn id="82" idx="1"/>
            <a:endCxn id="17" idx="3"/>
          </p:cNvCxnSpPr>
          <p:nvPr/>
        </p:nvCxnSpPr>
        <p:spPr>
          <a:xfrm flipH="1" flipV="1">
            <a:off x="4551625" y="3767982"/>
            <a:ext cx="1123338" cy="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A8AED6C9-1CB6-964D-B4BC-956DDFD2334F}"/>
              </a:ext>
            </a:extLst>
          </p:cNvPr>
          <p:cNvCxnSpPr>
            <a:cxnSpLocks/>
            <a:stCxn id="17" idx="2"/>
            <a:endCxn id="106" idx="0"/>
          </p:cNvCxnSpPr>
          <p:nvPr/>
        </p:nvCxnSpPr>
        <p:spPr>
          <a:xfrm>
            <a:off x="3948583" y="4137314"/>
            <a:ext cx="0" cy="4704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C72ED72A-2B36-E442-A7F2-C72056203B59}"/>
              </a:ext>
            </a:extLst>
          </p:cNvPr>
          <p:cNvCxnSpPr>
            <a:cxnSpLocks/>
            <a:stCxn id="106" idx="2"/>
            <a:endCxn id="77" idx="0"/>
          </p:cNvCxnSpPr>
          <p:nvPr/>
        </p:nvCxnSpPr>
        <p:spPr>
          <a:xfrm>
            <a:off x="3948583" y="5346474"/>
            <a:ext cx="0" cy="16628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AE0B3359-ED0C-9943-A1C7-78CB81EF3E84}"/>
              </a:ext>
            </a:extLst>
          </p:cNvPr>
          <p:cNvCxnSpPr>
            <a:cxnSpLocks/>
            <a:stCxn id="77" idx="2"/>
            <a:endCxn id="78" idx="0"/>
          </p:cNvCxnSpPr>
          <p:nvPr/>
        </p:nvCxnSpPr>
        <p:spPr>
          <a:xfrm>
            <a:off x="3948583" y="6035983"/>
            <a:ext cx="0" cy="15907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5865BEF6-648E-F04F-9818-D9ACF621AD81}"/>
              </a:ext>
            </a:extLst>
          </p:cNvPr>
          <p:cNvSpPr txBox="1"/>
          <p:nvPr/>
        </p:nvSpPr>
        <p:spPr>
          <a:xfrm>
            <a:off x="3834749" y="4219710"/>
            <a:ext cx="99097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15 days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8D61F1A-301C-9249-94A1-BC45A80BD452}"/>
              </a:ext>
            </a:extLst>
          </p:cNvPr>
          <p:cNvSpPr txBox="1"/>
          <p:nvPr/>
        </p:nvSpPr>
        <p:spPr>
          <a:xfrm>
            <a:off x="3745348" y="708693"/>
            <a:ext cx="99097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&lt; 2 h</a:t>
            </a:r>
          </a:p>
        </p:txBody>
      </p:sp>
      <p:cxnSp>
        <p:nvCxnSpPr>
          <p:cNvPr id="139" name="Elbow Connector 138">
            <a:extLst>
              <a:ext uri="{FF2B5EF4-FFF2-40B4-BE49-F238E27FC236}">
                <a16:creationId xmlns:a16="http://schemas.microsoft.com/office/drawing/2014/main" id="{A76890A1-E4EC-2F44-AD49-73B8CCE671C7}"/>
              </a:ext>
            </a:extLst>
          </p:cNvPr>
          <p:cNvCxnSpPr>
            <a:cxnSpLocks/>
            <a:stCxn id="5" idx="3"/>
            <a:endCxn id="10" idx="0"/>
          </p:cNvCxnSpPr>
          <p:nvPr/>
        </p:nvCxnSpPr>
        <p:spPr>
          <a:xfrm>
            <a:off x="5018880" y="2323326"/>
            <a:ext cx="1064079" cy="339912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5">
            <a:extLst>
              <a:ext uri="{FF2B5EF4-FFF2-40B4-BE49-F238E27FC236}">
                <a16:creationId xmlns:a16="http://schemas.microsoft.com/office/drawing/2014/main" id="{799C12A4-1937-7444-B528-F1663B63C885}"/>
              </a:ext>
            </a:extLst>
          </p:cNvPr>
          <p:cNvSpPr txBox="1"/>
          <p:nvPr/>
        </p:nvSpPr>
        <p:spPr>
          <a:xfrm>
            <a:off x="4847064" y="4855812"/>
            <a:ext cx="215218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>
                <a:latin typeface="Helvetica" pitchFamily="2" charset="0"/>
              </a:rPr>
              <a:t>Multiparameter</a:t>
            </a:r>
            <a:r>
              <a:rPr lang="en-US" sz="1400" dirty="0">
                <a:latin typeface="Helvetica" pitchFamily="2" charset="0"/>
              </a:rPr>
              <a:t> cytometry</a:t>
            </a:r>
          </a:p>
        </p:txBody>
      </p:sp>
      <p:cxnSp>
        <p:nvCxnSpPr>
          <p:cNvPr id="45" name="Elbow Connector 20">
            <a:extLst>
              <a:ext uri="{FF2B5EF4-FFF2-40B4-BE49-F238E27FC236}">
                <a16:creationId xmlns:a16="http://schemas.microsoft.com/office/drawing/2014/main" id="{DAE5C14C-E0A3-9141-8AA9-C0AD7B1D895C}"/>
              </a:ext>
            </a:extLst>
          </p:cNvPr>
          <p:cNvCxnSpPr>
            <a:cxnSpLocks/>
            <a:stCxn id="82" idx="1"/>
            <a:endCxn id="44" idx="0"/>
          </p:cNvCxnSpPr>
          <p:nvPr/>
        </p:nvCxnSpPr>
        <p:spPr>
          <a:xfrm rot="10800000" flipH="1" flipV="1">
            <a:off x="5674963" y="3767982"/>
            <a:ext cx="248194" cy="1087829"/>
          </a:xfrm>
          <a:prstGeom prst="bentConnector4">
            <a:avLst>
              <a:gd name="adj1" fmla="val -92105"/>
              <a:gd name="adj2" fmla="val 57073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612776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3</cp:revision>
  <dcterms:created xsi:type="dcterms:W3CDTF">2018-04-21T20:43:31Z</dcterms:created>
  <dcterms:modified xsi:type="dcterms:W3CDTF">2018-06-08T14:40:47Z</dcterms:modified>
</cp:coreProperties>
</file>